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4" r:id="rId2"/>
    <p:sldId id="26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2" autoAdjust="0"/>
    <p:restoredTop sz="94343" autoAdjust="0"/>
  </p:normalViewPr>
  <p:slideViewPr>
    <p:cSldViewPr snapToGrid="0">
      <p:cViewPr varScale="1">
        <p:scale>
          <a:sx n="112" d="100"/>
          <a:sy n="112" d="100"/>
        </p:scale>
        <p:origin x="43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B9F4D6-5374-402D-B6DB-4383C744AE73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9D64A1-33DE-468C-9F37-2C58A72F5D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6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</a:t>
            </a:r>
            <a:r>
              <a:rPr lang="en-US" baseline="0" dirty="0"/>
              <a:t> 1 (a, b) SNP array and FISH results showing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q27.1q28 deletion in the Proband-1; (c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) showing </a:t>
            </a:r>
            <a:r>
              <a:rPr lang="en-US" baseline="0" dirty="0"/>
              <a:t>SNP array (mother) and FISH (father) are normal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9D64A1-33DE-468C-9F37-2C58A72F5DC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196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</a:t>
            </a:r>
            <a:r>
              <a:rPr lang="en-US" baseline="0" dirty="0"/>
              <a:t> 2 (a, b) SNP array and FISH results showing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q27.1q28 deletion in the Proband-2; (c) showing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baseline="0" dirty="0"/>
              <a:t>FISH (mother) is normal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9D64A1-33DE-468C-9F37-2C58A72F5DC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549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590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026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105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58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4823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041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022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249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356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274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408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D93D6-6824-4FBB-9E7D-EA533E982884}" type="datetimeFigureOut">
              <a:rPr lang="en-US" smtClean="0"/>
              <a:t>12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DFAE2-B3ED-494E-95C5-47A569CD5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999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346670" y="2814957"/>
            <a:ext cx="7832558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oband-1                                                                                            </a:t>
            </a:r>
            <a:r>
              <a:rPr lang="en-US" dirty="0" err="1"/>
              <a:t>Proband-1</a:t>
            </a:r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Mother                                                                                                  Father</a:t>
            </a:r>
          </a:p>
          <a:p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7938" y="264886"/>
            <a:ext cx="5284695" cy="2498906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015379" y="3517872"/>
            <a:ext cx="5440077" cy="262029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13649" y="167183"/>
            <a:ext cx="2901050" cy="2447617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7751168" y="3621991"/>
            <a:ext cx="2705698" cy="2356249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5305141" y="6415943"/>
            <a:ext cx="230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38740" y="167183"/>
            <a:ext cx="7212428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)                                                                                                                          c)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b)                                                                                                                           d)</a:t>
            </a:r>
          </a:p>
        </p:txBody>
      </p:sp>
    </p:spTree>
    <p:extLst>
      <p:ext uri="{BB962C8B-B14F-4D97-AF65-F5344CB8AC3E}">
        <p14:creationId xmlns:p14="http://schemas.microsoft.com/office/powerpoint/2010/main" val="645400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757700" y="0"/>
            <a:ext cx="7862550" cy="2914303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23765" y="3336769"/>
            <a:ext cx="3078598" cy="2530925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6507570" y="3304216"/>
            <a:ext cx="3112680" cy="2592038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289480" y="2729637"/>
            <a:ext cx="12180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Proband-2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633944" y="6052360"/>
            <a:ext cx="5793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roband-2                                                                          Mother</a:t>
            </a:r>
          </a:p>
        </p:txBody>
      </p:sp>
      <p:sp>
        <p:nvSpPr>
          <p:cNvPr id="7" name="Rectangle 6"/>
          <p:cNvSpPr/>
          <p:nvPr/>
        </p:nvSpPr>
        <p:spPr>
          <a:xfrm>
            <a:off x="4913625" y="6393132"/>
            <a:ext cx="236475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09934" y="191069"/>
            <a:ext cx="5464958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/>
              <a:t>b)                                                                                              c)</a:t>
            </a:r>
          </a:p>
        </p:txBody>
      </p:sp>
    </p:spTree>
    <p:extLst>
      <p:ext uri="{BB962C8B-B14F-4D97-AF65-F5344CB8AC3E}">
        <p14:creationId xmlns:p14="http://schemas.microsoft.com/office/powerpoint/2010/main" val="2249515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99</Words>
  <Application>Microsoft Office PowerPoint</Application>
  <PresentationFormat>Widescreen</PresentationFormat>
  <Paragraphs>4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ua, Subit</dc:creator>
  <cp:lastModifiedBy>Liao, Jun</cp:lastModifiedBy>
  <cp:revision>19</cp:revision>
  <dcterms:created xsi:type="dcterms:W3CDTF">2020-02-27T19:56:09Z</dcterms:created>
  <dcterms:modified xsi:type="dcterms:W3CDTF">2021-12-03T14:39:02Z</dcterms:modified>
</cp:coreProperties>
</file>